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60" r:id="rId5"/>
    <p:sldId id="262" r:id="rId6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3" roundtripDataSignature="AMtx7mi+j9NdMDAzH81l0fkNAmLMaJt55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customschemas.google.com/relationships/presentationmetadata" Target="metadata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4" Type="http://schemas.openxmlformats.org/officeDocument/2006/relationships/slide" Target="slides/slide3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7" name="Google Shape;87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g1f1be127544_1_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6" name="Google Shape;96;g1f1be127544_1_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7" name="Google Shape;97;g1f1be127544_1_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2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3" name="Google Shape;10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0" name="Google Shape;120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6" name="Google Shape;136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빈 화면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제목 및 세로 텍스트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7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세로 제목 및 텍스트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8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8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제목만" type="titleOnly">
  <p:cSld name="TITLE_ONLY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제목 슬라이드" type="title">
  <p:cSld name="TITLE">
    <p:spTree>
      <p:nvGrpSpPr>
        <p:cNvPr id="1" name="Shape 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10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0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7" name="Google Shape;27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제목 및 내용" type="obj">
  <p:cSld name="OBJECT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구역 머리글" type="secHead">
  <p:cSld name="SECTION_HEADER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2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콘텐츠 2개" type="twoObj">
  <p:cSld name="TWO_OBJECTS">
    <p:spTree>
      <p:nvGrpSpPr>
        <p:cNvPr id="1" name="Shape 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Google Shape;43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비교" type="twoTxTwoObj">
  <p:cSld name="TWO_OBJECTS_WITH_TEXT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4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4" name="Google Shape;54;p14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5" name="Google Shape;5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캡션 있는 콘텐츠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5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5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캡션 있는 그림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6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6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6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1"/>
          <p:cNvSpPr txBox="1"/>
          <p:nvPr/>
        </p:nvSpPr>
        <p:spPr>
          <a:xfrm>
            <a:off x="212942" y="1008346"/>
            <a:ext cx="5052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0" name="Google Shape;90;p1"/>
          <p:cNvSpPr txBox="1"/>
          <p:nvPr/>
        </p:nvSpPr>
        <p:spPr>
          <a:xfrm>
            <a:off x="6302679" y="1008346"/>
            <a:ext cx="5052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91" name="Google Shape;91;p1"/>
          <p:cNvGraphicFramePr/>
          <p:nvPr/>
        </p:nvGraphicFramePr>
        <p:xfrm>
          <a:off x="6302679" y="1557673"/>
          <a:ext cx="5715000" cy="385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5715000" imgH="3854450" progId="Prism8.Document">
                  <p:embed/>
                </p:oleObj>
              </mc:Choice>
              <mc:Fallback>
                <p:oleObj r:id="rId3" imgW="5715000" imgH="3854450" progId="Prism8.Document">
                  <p:embed/>
                  <p:pic>
                    <p:nvPicPr>
                      <p:cNvPr id="91" name="Google Shape;91;p1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/>
                    </p:blipFill>
                    <p:spPr>
                      <a:xfrm>
                        <a:off x="6302679" y="1557673"/>
                        <a:ext cx="5715000" cy="3854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2" name="Google Shape;92;p1"/>
          <p:cNvGraphicFramePr/>
          <p:nvPr/>
        </p:nvGraphicFramePr>
        <p:xfrm>
          <a:off x="465575" y="1557673"/>
          <a:ext cx="5707063" cy="385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5707063" imgH="3854450" progId="Prism8.Document">
                  <p:embed/>
                </p:oleObj>
              </mc:Choice>
              <mc:Fallback>
                <p:oleObj r:id="rId5" imgW="5707063" imgH="3854450" progId="Prism8.Document">
                  <p:embed/>
                  <p:pic>
                    <p:nvPicPr>
                      <p:cNvPr id="92" name="Google Shape;92;p1"/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/>
                      <a:stretch/>
                    </p:blipFill>
                    <p:spPr>
                      <a:xfrm>
                        <a:off x="465575" y="1557673"/>
                        <a:ext cx="5707063" cy="3854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93" name="Google Shape;93;p1"/>
          <p:cNvSpPr txBox="1"/>
          <p:nvPr/>
        </p:nvSpPr>
        <p:spPr>
          <a:xfrm>
            <a:off x="212950" y="264900"/>
            <a:ext cx="73836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</a:rPr>
              <a:t>Supplementary</a:t>
            </a:r>
            <a:r>
              <a:rPr lang="ko-KR" altLang="en-US" sz="1800" b="1" dirty="0">
                <a:solidFill>
                  <a:schemeClr val="dk1"/>
                </a:solidFill>
              </a:rPr>
              <a:t> </a:t>
            </a:r>
            <a:r>
              <a:rPr lang="en-US" sz="1800" b="1" dirty="0">
                <a:solidFill>
                  <a:schemeClr val="dk1"/>
                </a:solidFill>
              </a:rPr>
              <a:t>Figure 1.</a:t>
            </a:r>
            <a:endParaRPr sz="1800" b="1" dirty="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g1f1be127544_1_2"/>
          <p:cNvSpPr txBox="1"/>
          <p:nvPr/>
        </p:nvSpPr>
        <p:spPr>
          <a:xfrm>
            <a:off x="212950" y="264900"/>
            <a:ext cx="73836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</a:rPr>
              <a:t>Supplementary Figure 2.</a:t>
            </a:r>
            <a:endParaRPr sz="1800" b="1" dirty="0">
              <a:solidFill>
                <a:schemeClr val="dk1"/>
              </a:solidFill>
            </a:endParaRPr>
          </a:p>
        </p:txBody>
      </p:sp>
      <p:pic>
        <p:nvPicPr>
          <p:cNvPr id="100" name="Google Shape;100;g1f1be127544_1_2"/>
          <p:cNvPicPr preferRelativeResize="0"/>
          <p:nvPr/>
        </p:nvPicPr>
        <p:blipFill rotWithShape="1">
          <a:blip r:embed="rId3">
            <a:alphaModFix/>
          </a:blip>
          <a:srcRect t="5767"/>
          <a:stretch/>
        </p:blipFill>
        <p:spPr>
          <a:xfrm>
            <a:off x="3182700" y="1226100"/>
            <a:ext cx="5826601" cy="54905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2"/>
          <p:cNvSpPr txBox="1"/>
          <p:nvPr/>
        </p:nvSpPr>
        <p:spPr>
          <a:xfrm>
            <a:off x="608236" y="1742153"/>
            <a:ext cx="5052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800" b="1">
                <a:solidFill>
                  <a:schemeClr val="dk1"/>
                </a:solidFill>
              </a:rPr>
              <a:t>A</a:t>
            </a: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9" name="Google Shape;109;p2"/>
          <p:cNvSpPr txBox="1"/>
          <p:nvPr/>
        </p:nvSpPr>
        <p:spPr>
          <a:xfrm>
            <a:off x="212950" y="264900"/>
            <a:ext cx="73836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</a:rPr>
              <a:t>Supplementary Figure 3.</a:t>
            </a:r>
            <a:endParaRPr sz="1800" b="1" dirty="0">
              <a:solidFill>
                <a:schemeClr val="dk1"/>
              </a:solidFill>
            </a:endParaRPr>
          </a:p>
        </p:txBody>
      </p:sp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00E55A9B-E7DA-956C-1F61-FC77EA8543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0462845"/>
              </p:ext>
            </p:extLst>
          </p:nvPr>
        </p:nvGraphicFramePr>
        <p:xfrm>
          <a:off x="366251" y="2165854"/>
          <a:ext cx="5715000" cy="385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5714274" imgH="3853749" progId="Prism8.Document">
                  <p:embed/>
                </p:oleObj>
              </mc:Choice>
              <mc:Fallback>
                <p:oleObj name="Prism 8" r:id="rId3" imgW="5714274" imgH="385374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6251" y="2165854"/>
                        <a:ext cx="5715000" cy="385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6" name="Google Shape;116;p3"/>
          <p:cNvSpPr txBox="1"/>
          <p:nvPr/>
        </p:nvSpPr>
        <p:spPr>
          <a:xfrm>
            <a:off x="6352734" y="1742153"/>
            <a:ext cx="5052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800" b="1">
                <a:solidFill>
                  <a:schemeClr val="dk1"/>
                </a:solidFill>
              </a:rPr>
              <a:t>B</a:t>
            </a: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36B73E34-6A95-0C67-E1D0-9A44705E9F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9902890"/>
              </p:ext>
            </p:extLst>
          </p:nvPr>
        </p:nvGraphicFramePr>
        <p:xfrm>
          <a:off x="6110749" y="2165854"/>
          <a:ext cx="5715000" cy="385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5714274" imgH="3853749" progId="Prism8.Document">
                  <p:embed/>
                </p:oleObj>
              </mc:Choice>
              <mc:Fallback>
                <p:oleObj name="Prism 8" r:id="rId5" imgW="5714274" imgH="3853749" progId="Prism8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36B73E34-6A95-0C67-E1D0-9A44705E9F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10749" y="2165854"/>
                        <a:ext cx="5715000" cy="385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p4"/>
          <p:cNvSpPr txBox="1"/>
          <p:nvPr/>
        </p:nvSpPr>
        <p:spPr>
          <a:xfrm>
            <a:off x="543371" y="1560062"/>
            <a:ext cx="605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800" b="1">
                <a:solidFill>
                  <a:schemeClr val="dk1"/>
                </a:solidFill>
              </a:rPr>
              <a:t>C</a:t>
            </a: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2936A59D-0CBA-412D-A7BD-DFF9C3EA3E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3310644"/>
              </p:ext>
            </p:extLst>
          </p:nvPr>
        </p:nvGraphicFramePr>
        <p:xfrm>
          <a:off x="381000" y="2175796"/>
          <a:ext cx="5715000" cy="385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5714274" imgH="3853749" progId="Prism8.Document">
                  <p:embed/>
                </p:oleObj>
              </mc:Choice>
              <mc:Fallback>
                <p:oleObj name="Prism 8" r:id="rId3" imgW="5714274" imgH="385374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1000" y="2175796"/>
                        <a:ext cx="5715000" cy="385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1" name="Google Shape;131;p5"/>
          <p:cNvSpPr txBox="1"/>
          <p:nvPr/>
        </p:nvSpPr>
        <p:spPr>
          <a:xfrm>
            <a:off x="6341669" y="1560062"/>
            <a:ext cx="605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D)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D3CCF3E8-20B2-0F19-97B2-3FF38CE828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153023"/>
              </p:ext>
            </p:extLst>
          </p:nvPr>
        </p:nvGraphicFramePr>
        <p:xfrm>
          <a:off x="6096000" y="2175796"/>
          <a:ext cx="5715000" cy="385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5714274" imgH="3853749" progId="Prism8.Document">
                  <p:embed/>
                </p:oleObj>
              </mc:Choice>
              <mc:Fallback>
                <p:oleObj name="Prism 8" r:id="rId5" imgW="5714274" imgH="3853749" progId="Prism8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D3CCF3E8-20B2-0F19-97B2-3FF38CE828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96000" y="2175796"/>
                        <a:ext cx="5715000" cy="385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6"/>
          <p:cNvSpPr txBox="1"/>
          <p:nvPr/>
        </p:nvSpPr>
        <p:spPr>
          <a:xfrm>
            <a:off x="838200" y="1562787"/>
            <a:ext cx="51809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800" b="1">
                <a:solidFill>
                  <a:schemeClr val="dk1"/>
                </a:solidFill>
              </a:rPr>
              <a:t>E</a:t>
            </a: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B9768BE8-A2BD-2874-70A1-29DA85C227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1516373"/>
              </p:ext>
            </p:extLst>
          </p:nvPr>
        </p:nvGraphicFramePr>
        <p:xfrm>
          <a:off x="1251292" y="1932119"/>
          <a:ext cx="5715000" cy="385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5714274" imgH="3853749" progId="Prism8.Document">
                  <p:embed/>
                </p:oleObj>
              </mc:Choice>
              <mc:Fallback>
                <p:oleObj name="Prism 8" r:id="rId3" imgW="5714274" imgH="385374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51292" y="1932119"/>
                        <a:ext cx="5715000" cy="385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5</Words>
  <Application>Microsoft Office PowerPoint</Application>
  <PresentationFormat>와이드스크린</PresentationFormat>
  <Paragraphs>12</Paragraphs>
  <Slides>5</Slides>
  <Notes>5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5</vt:i4>
      </vt:variant>
    </vt:vector>
  </HeadingPairs>
  <TitlesOfParts>
    <vt:vector size="11" baseType="lpstr">
      <vt:lpstr>Malgun Gothic</vt:lpstr>
      <vt:lpstr>Arial</vt:lpstr>
      <vt:lpstr>Calibri</vt:lpstr>
      <vt:lpstr>Office 테마</vt:lpstr>
      <vt:lpstr>GraphPad Prism 8 Project</vt:lpstr>
      <vt:lpstr>Prism 8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지원</dc:creator>
  <cp:lastModifiedBy>김지원</cp:lastModifiedBy>
  <cp:revision>4</cp:revision>
  <dcterms:created xsi:type="dcterms:W3CDTF">2019-03-10T01:55:07Z</dcterms:created>
  <dcterms:modified xsi:type="dcterms:W3CDTF">2024-04-26T18:33:50Z</dcterms:modified>
</cp:coreProperties>
</file>